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embeddings/oleObject3.xlsx" ContentType="application/vnd.openxmlformats-officedocument.spreadsheetml.sheet"/>
  <Override PartName="/ppt/embeddings/oleObject4.xlsx" ContentType="application/vnd.openxmlformats-officedocument.spreadsheetml.sheet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087DFD-121F-4EE0-97B0-16150595965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E5A13E-5DDD-4C0C-B7D0-6E9904D1C38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842812-BAD4-4C23-9954-B70AB70F354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702BFC-C178-46D1-AFDE-EA9725BEC72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470F8C-EE1A-4219-9B13-22898CEC16E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7B9FC2-EEAE-416D-8E7E-081B5E41CF1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03C224-4D2D-46F7-A705-F42F2E1BB7E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1E415A-7086-474C-AEF6-B3FA57F1550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E6140F-43C1-4547-B4AE-C58FB6F3648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56C35C-85AC-4A14-984E-1B475B05C5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AF8AED-8DA6-4213-8B0C-8A6C78926EA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E6C05C-ECA0-40D6-A5E8-9543F6EBC19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400" spc="-1" strike="noStrike">
                <a:solidFill>
                  <a:srgbClr val="000000"/>
                </a:solidFill>
                <a:latin typeface="Arial"/>
                <a:ea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AD0623F-5CB8-42D0-BA66-810B515A3480}" type="slidenum">
              <a:rPr b="0" lang="ko-KR" sz="1400" spc="-1" strike="noStrike">
                <a:solidFill>
                  <a:srgbClr val="000000"/>
                </a:solidFill>
                <a:latin typeface="Arial"/>
                <a:ea typeface="굴림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2.wmf"/><Relationship Id="rId5" Type="http://schemas.openxmlformats.org/officeDocument/2006/relationships/package" Target="../embeddings/oleObject3.xlsx"/><Relationship Id="rId6" Type="http://schemas.openxmlformats.org/officeDocument/2006/relationships/image" Target="../media/image3.wmf"/><Relationship Id="rId7" Type="http://schemas.openxmlformats.org/officeDocument/2006/relationships/package" Target="../embeddings/oleObject4.xlsx"/><Relationship Id="rId8" Type="http://schemas.openxmlformats.org/officeDocument/2006/relationships/image" Target="../media/image4.wmf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450800" y="754200"/>
          <a:ext cx="2768760" cy="202248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450800" y="754200"/>
                    <a:ext cx="2768760" cy="20224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3" name=""/>
          <p:cNvSpPr/>
          <p:nvPr/>
        </p:nvSpPr>
        <p:spPr>
          <a:xfrm>
            <a:off x="831600" y="24444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굴림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 rot="16200000">
            <a:off x="1755360" y="2411640"/>
            <a:ext cx="362880" cy="653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HCT11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 rot="16200000">
            <a:off x="2424600" y="2504520"/>
            <a:ext cx="362880" cy="46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HT2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 rot="16200000">
            <a:off x="2995200" y="2467080"/>
            <a:ext cx="362880" cy="54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DLD-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 rot="16200000">
            <a:off x="3613320" y="2458080"/>
            <a:ext cx="362880" cy="56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SW48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1968840" y="63972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800" spc="-1" strike="noStrike">
                <a:solidFill>
                  <a:srgbClr val="000000"/>
                </a:solidFill>
                <a:latin typeface="Arial"/>
                <a:ea typeface="굴림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3807000" y="189072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800" spc="-1" strike="noStrike">
                <a:solidFill>
                  <a:srgbClr val="000000"/>
                </a:solidFill>
                <a:latin typeface="Arial"/>
                <a:ea typeface="굴림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0" name=""/>
          <p:cNvGrpSpPr/>
          <p:nvPr/>
        </p:nvGrpSpPr>
        <p:grpSpPr>
          <a:xfrm>
            <a:off x="803520" y="3429000"/>
            <a:ext cx="2790720" cy="2443320"/>
            <a:chOff x="803520" y="3429000"/>
            <a:chExt cx="2790720" cy="2443320"/>
          </a:xfrm>
        </p:grpSpPr>
        <p:graphicFrame>
          <p:nvGraphicFramePr>
            <p:cNvPr id="51" name=""/>
            <p:cNvGraphicFramePr/>
            <p:nvPr/>
          </p:nvGraphicFramePr>
          <p:xfrm>
            <a:off x="1373040" y="3763800"/>
            <a:ext cx="2221200" cy="2108520"/>
          </p:xfrm>
          <a:graphic>
            <a:graphicData uri="http://schemas.openxmlformats.org/presentationml/2006/ole">
              <p:oleObj progId="Excel.Sheet.12" r:id="rId3" spid="">
                <p:embed/>
                <p:pic>
                  <p:nvPicPr>
                    <p:cNvPr id="52" name="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1373040" y="3763800"/>
                      <a:ext cx="2221200" cy="21085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53" name=""/>
            <p:cNvSpPr/>
            <p:nvPr/>
          </p:nvSpPr>
          <p:spPr>
            <a:xfrm rot="16200000">
              <a:off x="615240" y="4623480"/>
              <a:ext cx="1287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굴림"/>
                </a:rPr>
                <a:t>2^-(</a:t>
              </a:r>
              <a:r>
                <a:rPr b="1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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굴림"/>
                </a:rPr>
                <a:t>Ct) X 100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803520" y="3429000"/>
              <a:ext cx="34992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B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5" name=""/>
          <p:cNvGrpSpPr/>
          <p:nvPr/>
        </p:nvGrpSpPr>
        <p:grpSpPr>
          <a:xfrm>
            <a:off x="4186080" y="3681360"/>
            <a:ext cx="4119840" cy="2310120"/>
            <a:chOff x="4186080" y="3681360"/>
            <a:chExt cx="4119840" cy="2310120"/>
          </a:xfrm>
        </p:grpSpPr>
        <p:graphicFrame>
          <p:nvGraphicFramePr>
            <p:cNvPr id="56" name=""/>
            <p:cNvGraphicFramePr/>
            <p:nvPr/>
          </p:nvGraphicFramePr>
          <p:xfrm>
            <a:off x="4498920" y="3681360"/>
            <a:ext cx="1325520" cy="2225880"/>
          </p:xfrm>
          <a:graphic>
            <a:graphicData uri="http://schemas.openxmlformats.org/presentationml/2006/ole">
              <p:oleObj progId="Excel.Sheet.12" r:id="rId5" spid="">
                <p:embed/>
                <p:pic>
                  <p:nvPicPr>
                    <p:cNvPr id="57" name="" descr=""/>
                    <p:cNvPicPr/>
                    <p:nvPr/>
                  </p:nvPicPr>
                  <p:blipFill>
                    <a:blip r:embed="rId6"/>
                    <a:stretch/>
                  </p:blipFill>
                  <p:spPr>
                    <a:xfrm>
                      <a:off x="4498920" y="3681360"/>
                      <a:ext cx="1325520" cy="22258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58" name=""/>
            <p:cNvGraphicFramePr/>
            <p:nvPr/>
          </p:nvGraphicFramePr>
          <p:xfrm>
            <a:off x="5943600" y="3681360"/>
            <a:ext cx="2362320" cy="2209680"/>
          </p:xfrm>
          <a:graphic>
            <a:graphicData uri="http://schemas.openxmlformats.org/presentationml/2006/ole">
              <p:oleObj progId="Excel.Sheet.12" r:id="rId7" spid="">
                <p:embed/>
                <p:pic>
                  <p:nvPicPr>
                    <p:cNvPr id="59" name="" descr=""/>
                    <p:cNvPicPr/>
                    <p:nvPr/>
                  </p:nvPicPr>
                  <p:blipFill>
                    <a:blip r:embed="rId8"/>
                    <a:stretch/>
                  </p:blipFill>
                  <p:spPr>
                    <a:xfrm>
                      <a:off x="5943600" y="3681360"/>
                      <a:ext cx="2362320" cy="22096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60" name=""/>
            <p:cNvSpPr/>
            <p:nvPr/>
          </p:nvSpPr>
          <p:spPr>
            <a:xfrm>
              <a:off x="7638480" y="5715000"/>
              <a:ext cx="646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SW48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4876920" y="5715000"/>
              <a:ext cx="742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HCT11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6597360" y="5715000"/>
              <a:ext cx="554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HT29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7107120" y="5715000"/>
              <a:ext cx="628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DLD-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 rot="16200000">
              <a:off x="3680640" y="4624560"/>
              <a:ext cx="1287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굴림"/>
                </a:rPr>
                <a:t>2^-(</a:t>
              </a:r>
              <a:r>
                <a:rPr b="1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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굴림"/>
                </a:rPr>
                <a:t>Ct) X 100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5" name=""/>
          <p:cNvSpPr/>
          <p:nvPr/>
        </p:nvSpPr>
        <p:spPr>
          <a:xfrm>
            <a:off x="3963960" y="342900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굴림"/>
              </a:rPr>
              <a:t>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6860160" y="0"/>
            <a:ext cx="2268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Myoung S. Kim et al., Figure S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3015720" y="5680080"/>
            <a:ext cx="646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SW48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1454040" y="5697360"/>
            <a:ext cx="743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HCT11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2087280" y="5697360"/>
            <a:ext cx="554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HT2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2528640" y="5697360"/>
            <a:ext cx="62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DLD-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 rot="16200000">
            <a:off x="398880" y="1454760"/>
            <a:ext cx="16772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굴림"/>
              </a:rPr>
              <a:t>Relative Expression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굴림"/>
              </a:rPr>
              <a:t>(Fold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8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5-29T15:45:24Z</dcterms:created>
  <dc:creator>mkim51</dc:creator>
  <dc:description/>
  <dc:language>en-US</dc:language>
  <cp:lastModifiedBy>mkim51</cp:lastModifiedBy>
  <dcterms:modified xsi:type="dcterms:W3CDTF">2009-07-08T18:05:15Z</dcterms:modified>
  <cp:revision>49</cp:revision>
  <dc:subject/>
  <dc:title>Slide 1</dc:title>
</cp:coreProperties>
</file>